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handoutMasterIdLst>
    <p:handoutMasterId r:id="rId9"/>
  </p:handoutMasterIdLst>
  <p:sldIdLst>
    <p:sldId id="256" r:id="rId2"/>
    <p:sldId id="347" r:id="rId3"/>
    <p:sldId id="346" r:id="rId4"/>
    <p:sldId id="350" r:id="rId5"/>
    <p:sldId id="331" r:id="rId6"/>
    <p:sldId id="330" r:id="rId7"/>
  </p:sldIdLst>
  <p:sldSz cx="6858000" cy="9144000" type="screen4x3"/>
  <p:notesSz cx="6669088" cy="9872663"/>
  <p:defaultTextStyle>
    <a:defPPr>
      <a:defRPr lang="fi-FI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903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110" userDrawn="1">
          <p15:clr>
            <a:srgbClr val="A4A3A4"/>
          </p15:clr>
        </p15:guide>
        <p15:guide id="2" pos="2101" userDrawn="1">
          <p15:clr>
            <a:srgbClr val="A4A3A4"/>
          </p15:clr>
        </p15:guide>
      </p15:notes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uan-Yin, Tseng" initials="KT" lastIdx="1" clrIdx="0">
    <p:extLst>
      <p:ext uri="{19B8F6BF-5375-455C-9EA6-DF929625EA0E}">
        <p15:presenceInfo xmlns:p15="http://schemas.microsoft.com/office/powerpoint/2012/main" userId="S-1-5-21-16020293-282541685-632688529-207943" providerId="AD"/>
      </p:ext>
    </p:extLst>
  </p:cmAuthor>
  <p:cmAuthor id="2" name="kuan-yin tseng" initials="kyt" lastIdx="1" clrIdx="1">
    <p:extLst>
      <p:ext uri="{19B8F6BF-5375-455C-9EA6-DF929625EA0E}">
        <p15:presenceInfo xmlns:p15="http://schemas.microsoft.com/office/powerpoint/2012/main" userId="d75ebb3e5b67559d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6FF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87" autoAdjust="0"/>
    <p:restoredTop sz="82478" autoAdjust="0"/>
  </p:normalViewPr>
  <p:slideViewPr>
    <p:cSldViewPr>
      <p:cViewPr>
        <p:scale>
          <a:sx n="66" d="100"/>
          <a:sy n="66" d="100"/>
        </p:scale>
        <p:origin x="1950" y="-552"/>
      </p:cViewPr>
      <p:guideLst>
        <p:guide orient="horz" pos="2903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notesViewPr>
    <p:cSldViewPr>
      <p:cViewPr varScale="1">
        <p:scale>
          <a:sx n="102" d="100"/>
          <a:sy n="102" d="100"/>
        </p:scale>
        <p:origin x="-3558" y="-90"/>
      </p:cViewPr>
      <p:guideLst>
        <p:guide orient="horz" pos="3110"/>
        <p:guide pos="2101"/>
      </p:guideLst>
    </p:cSldViewPr>
  </p:notesViewPr>
  <p:gridSpacing cx="36004" cy="36004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handoutMaster" Target="handoutMasters/handoutMaster1.xml"/><Relationship Id="rId14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9938" cy="49363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i-FI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777607" y="0"/>
            <a:ext cx="2889938" cy="49363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219005A-18EF-4204-86B5-982C0DEF7B8E}" type="datetimeFigureOut">
              <a:rPr lang="fi-FI" smtClean="0"/>
              <a:t>19.6.2022</a:t>
            </a:fld>
            <a:endParaRPr lang="fi-FI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377316"/>
            <a:ext cx="2889938" cy="49363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i-FI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777607" y="9377316"/>
            <a:ext cx="2889938" cy="49363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7D72AB6-467C-4796-9C81-AF3C011DFE9B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89138176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9938" cy="49363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i-FI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777607" y="0"/>
            <a:ext cx="2889938" cy="49363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6B13E36-E5CE-49F8-9C41-5F34F999EAA0}" type="datetimeFigureOut">
              <a:rPr lang="fi-FI" smtClean="0"/>
              <a:t>19.6.2022</a:t>
            </a:fld>
            <a:endParaRPr lang="fi-FI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946275" y="739775"/>
            <a:ext cx="2776538" cy="37036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i-FI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66909" y="4689515"/>
            <a:ext cx="5335270" cy="444269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377316"/>
            <a:ext cx="2889938" cy="49363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i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777607" y="9377316"/>
            <a:ext cx="2889938" cy="49363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C7BFE12-F416-41FF-88D1-45D9352A83F6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9907584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ry Figure S1. </a:t>
            </a:r>
            <a:r>
              <a:rPr lang="en-US" dirty="0"/>
              <a:t>Summary of viability of BV2 cell in response to different dosage of 6-OHDA for 24 hours.</a:t>
            </a: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C7BFE12-F416-41FF-88D1-45D9352A83F6}" type="slidenum">
              <a:rPr lang="fi-FI" smtClean="0"/>
              <a:t>3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32816027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b="1" dirty="0">
                <a:effectLst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Supplementary Figure S2. </a:t>
            </a:r>
            <a:r>
              <a:rPr lang="en-US" sz="1800" dirty="0">
                <a:effectLst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All animals were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immunohisochemically</a:t>
            </a:r>
            <a:r>
              <a:rPr lang="en-US" sz="1800" dirty="0">
                <a:effectLst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 stained for TH to examine the loss of dopaminergic neurons in right substantia nigra at 2 months after transplantation. (A) Vehicle group. (B) rhCDNF alone group. (C) 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rVM</a:t>
            </a:r>
            <a:r>
              <a:rPr lang="en-US" sz="1800" dirty="0">
                <a:effectLst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 group. (D)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rVM+rhCDNF</a:t>
            </a:r>
            <a:r>
              <a:rPr lang="en-US" sz="1800" dirty="0">
                <a:effectLst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 group.</a:t>
            </a:r>
            <a:endParaRPr lang="en-US" sz="1800" dirty="0">
              <a:effectLst/>
              <a:latin typeface="Calibri" panose="020F0502020204030204" pitchFamily="34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C7BFE12-F416-41FF-88D1-45D9352A83F6}" type="slidenum">
              <a:rPr lang="fi-FI" smtClean="0"/>
              <a:t>4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49385235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ry Figure S3</a:t>
            </a:r>
            <a:r>
              <a:rPr lang="en-US" dirty="0"/>
              <a:t>. Heatmap plot of upregulated DEGs in BV2 cell lines between 6-OHDA and 6-OHDA+rhCDNF.</a:t>
            </a: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C7BFE12-F416-41FF-88D1-45D9352A83F6}" type="slidenum">
              <a:rPr lang="fi-FI" smtClean="0"/>
              <a:t>5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57143401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ry Figure S4 </a:t>
            </a:r>
            <a:r>
              <a:rPr lang="en-US" dirty="0"/>
              <a:t>Heatmap plot of downregulated DEGs in BV2 cell lines between 6-OHDA and 6-OHDA+rhCDNF.</a:t>
            </a: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C7BFE12-F416-41FF-88D1-45D9352A83F6}" type="slidenum">
              <a:rPr lang="fi-FI" smtClean="0"/>
              <a:t>6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78835594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fi-F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ECEC16-366F-4AAC-A656-832500B56BB5}" type="datetimeFigureOut">
              <a:rPr lang="fi-FI" smtClean="0"/>
              <a:t>19.6.2022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ECC5F7-912F-4847-955D-CD3633E28D08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925637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ECEC16-366F-4AAC-A656-832500B56BB5}" type="datetimeFigureOut">
              <a:rPr lang="fi-FI" smtClean="0"/>
              <a:t>19.6.2022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ECC5F7-912F-4847-955D-CD3633E28D08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9692609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ECEC16-366F-4AAC-A656-832500B56BB5}" type="datetimeFigureOut">
              <a:rPr lang="fi-FI" smtClean="0"/>
              <a:t>19.6.2022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ECC5F7-912F-4847-955D-CD3633E28D08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0480574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ECEC16-366F-4AAC-A656-832500B56BB5}" type="datetimeFigureOut">
              <a:rPr lang="fi-FI" smtClean="0"/>
              <a:t>19.6.2022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ECC5F7-912F-4847-955D-CD3633E28D08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7111822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ECEC16-366F-4AAC-A656-832500B56BB5}" type="datetimeFigureOut">
              <a:rPr lang="fi-FI" smtClean="0"/>
              <a:t>19.6.2022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ECC5F7-912F-4847-955D-CD3633E28D08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0382220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ECEC16-366F-4AAC-A656-832500B56BB5}" type="datetimeFigureOut">
              <a:rPr lang="fi-FI" smtClean="0"/>
              <a:t>19.6.2022</a:t>
            </a:fld>
            <a:endParaRPr lang="fi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ECC5F7-912F-4847-955D-CD3633E28D08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127086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ECEC16-366F-4AAC-A656-832500B56BB5}" type="datetimeFigureOut">
              <a:rPr lang="fi-FI" smtClean="0"/>
              <a:t>19.6.2022</a:t>
            </a:fld>
            <a:endParaRPr lang="fi-FI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ECC5F7-912F-4847-955D-CD3633E28D08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5741799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ECEC16-366F-4AAC-A656-832500B56BB5}" type="datetimeFigureOut">
              <a:rPr lang="fi-FI" smtClean="0"/>
              <a:t>19.6.2022</a:t>
            </a:fld>
            <a:endParaRPr lang="fi-FI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ECC5F7-912F-4847-955D-CD3633E28D08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7256760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ECEC16-366F-4AAC-A656-832500B56BB5}" type="datetimeFigureOut">
              <a:rPr lang="fi-FI" smtClean="0"/>
              <a:t>19.6.2022</a:t>
            </a:fld>
            <a:endParaRPr lang="fi-FI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ECC5F7-912F-4847-955D-CD3633E28D08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8504161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ECEC16-366F-4AAC-A656-832500B56BB5}" type="datetimeFigureOut">
              <a:rPr lang="fi-FI" smtClean="0"/>
              <a:t>19.6.2022</a:t>
            </a:fld>
            <a:endParaRPr lang="fi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ECC5F7-912F-4847-955D-CD3633E28D08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5818115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i-FI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ECEC16-366F-4AAC-A656-832500B56BB5}" type="datetimeFigureOut">
              <a:rPr lang="fi-FI" smtClean="0"/>
              <a:t>19.6.2022</a:t>
            </a:fld>
            <a:endParaRPr lang="fi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ECC5F7-912F-4847-955D-CD3633E28D08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1115459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ECEC16-366F-4AAC-A656-832500B56BB5}" type="datetimeFigureOut">
              <a:rPr lang="fi-FI" smtClean="0"/>
              <a:t>19.6.2022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ECC5F7-912F-4847-955D-CD3633E28D08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7927923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i-FI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3" Type="http://schemas.openxmlformats.org/officeDocument/2006/relationships/image" Target="../media/image2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microsoft.com/office/2007/relationships/hdphoto" Target="../media/hdphoto1.wdp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1"/>
          <p:cNvSpPr>
            <a:spLocks noGrp="1"/>
          </p:cNvSpPr>
          <p:nvPr>
            <p:ph type="ctrTitle"/>
          </p:nvPr>
        </p:nvSpPr>
        <p:spPr>
          <a:xfrm>
            <a:off x="260648" y="2611967"/>
            <a:ext cx="6336704" cy="1960033"/>
          </a:xfrm>
        </p:spPr>
        <p:txBody>
          <a:bodyPr>
            <a:normAutofit/>
          </a:bodyPr>
          <a:lstStyle/>
          <a:p>
            <a:pPr>
              <a:tabLst>
                <a:tab pos="5734050" algn="l"/>
              </a:tabLst>
            </a:pPr>
            <a:r>
              <a:rPr lang="en-US" sz="2400" b="1" dirty="0"/>
              <a:t>Modulating Microglia/Macrophage Activation by CDNF Promotes Transplantation of Fetal Ventral Mesencephalic Graft Survival and Function in a Hemi-parkinsonian Rat Model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25776021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34BA1D5-5180-4CDC-93AC-6E1C730BE2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40668" y="3203848"/>
            <a:ext cx="6172200" cy="1524000"/>
          </a:xfrm>
        </p:spPr>
        <p:txBody>
          <a:bodyPr/>
          <a:lstStyle/>
          <a:p>
            <a:r>
              <a:rPr lang="en-US" dirty="0"/>
              <a:t>Supplement</a:t>
            </a:r>
          </a:p>
        </p:txBody>
      </p:sp>
    </p:spTree>
    <p:extLst>
      <p:ext uri="{BB962C8B-B14F-4D97-AF65-F5344CB8AC3E}">
        <p14:creationId xmlns:p14="http://schemas.microsoft.com/office/powerpoint/2010/main" val="10141188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53F9DABB-3927-43ED-913E-8E297623807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1500" y="1007604"/>
            <a:ext cx="2857500" cy="37109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8677610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组合 9">
            <a:extLst>
              <a:ext uri="{FF2B5EF4-FFF2-40B4-BE49-F238E27FC236}">
                <a16:creationId xmlns:a16="http://schemas.microsoft.com/office/drawing/2014/main" id="{A8DF99F9-A55B-6DAE-1772-119719A177CD}"/>
              </a:ext>
            </a:extLst>
          </p:cNvPr>
          <p:cNvGrpSpPr/>
          <p:nvPr/>
        </p:nvGrpSpPr>
        <p:grpSpPr>
          <a:xfrm>
            <a:off x="0" y="58714"/>
            <a:ext cx="6732808" cy="4621750"/>
            <a:chOff x="0" y="58714"/>
            <a:chExt cx="6732808" cy="4621750"/>
          </a:xfrm>
        </p:grpSpPr>
        <p:pic>
          <p:nvPicPr>
            <p:cNvPr id="2" name="图片 1">
              <a:extLst>
                <a:ext uri="{FF2B5EF4-FFF2-40B4-BE49-F238E27FC236}">
                  <a16:creationId xmlns:a16="http://schemas.microsoft.com/office/drawing/2014/main" id="{8F73E180-D9DE-D88C-AFEC-5DA7CE704A6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grayscl/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contrast="-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04664" y="287524"/>
              <a:ext cx="2880000" cy="1929395"/>
            </a:xfrm>
            <a:prstGeom prst="rect">
              <a:avLst/>
            </a:prstGeom>
          </p:spPr>
        </p:pic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999B3C97-80FD-A408-619B-46613D7FD61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grayscl/>
            </a:blip>
            <a:stretch>
              <a:fillRect/>
            </a:stretch>
          </p:blipFill>
          <p:spPr>
            <a:xfrm>
              <a:off x="3753036" y="287523"/>
              <a:ext cx="2880000" cy="1929395"/>
            </a:xfrm>
            <a:prstGeom prst="rect">
              <a:avLst/>
            </a:prstGeom>
          </p:spPr>
        </p:pic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55F0A89A-E7F7-B332-BFC4-1F66C9E2E0B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grayscl/>
            </a:blip>
            <a:stretch>
              <a:fillRect/>
            </a:stretch>
          </p:blipFill>
          <p:spPr>
            <a:xfrm>
              <a:off x="440668" y="2738258"/>
              <a:ext cx="2880000" cy="1942206"/>
            </a:xfrm>
            <a:prstGeom prst="rect">
              <a:avLst/>
            </a:prstGeom>
          </p:spPr>
        </p:pic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CC17B232-EF7A-E0F3-C764-C84D675421BD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grayscl/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sharpenSoften amount="25000"/>
                      </a14:imgEffect>
                      <a14:imgEffect>
                        <a14:brightnessContrast contrast="-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852808" y="2738258"/>
              <a:ext cx="2880000" cy="1760285"/>
            </a:xfrm>
            <a:prstGeom prst="rect">
              <a:avLst/>
            </a:prstGeom>
          </p:spPr>
        </p:pic>
        <p:sp>
          <p:nvSpPr>
            <p:cNvPr id="6" name="Rectangle 106">
              <a:extLst>
                <a:ext uri="{FF2B5EF4-FFF2-40B4-BE49-F238E27FC236}">
                  <a16:creationId xmlns:a16="http://schemas.microsoft.com/office/drawing/2014/main" id="{02B2B4FF-0AA7-34C0-93E3-67A2C336DFCB}"/>
                </a:ext>
              </a:extLst>
            </p:cNvPr>
            <p:cNvSpPr/>
            <p:nvPr/>
          </p:nvSpPr>
          <p:spPr>
            <a:xfrm>
              <a:off x="0" y="58714"/>
              <a:ext cx="314510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fi-FI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Rectangle 106">
              <a:extLst>
                <a:ext uri="{FF2B5EF4-FFF2-40B4-BE49-F238E27FC236}">
                  <a16:creationId xmlns:a16="http://schemas.microsoft.com/office/drawing/2014/main" id="{06552284-B41C-A0B4-AE28-2FCB9C38940D}"/>
                </a:ext>
              </a:extLst>
            </p:cNvPr>
            <p:cNvSpPr/>
            <p:nvPr/>
          </p:nvSpPr>
          <p:spPr>
            <a:xfrm>
              <a:off x="3361595" y="58714"/>
              <a:ext cx="304892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fi-FI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Rectangle 106">
              <a:extLst>
                <a:ext uri="{FF2B5EF4-FFF2-40B4-BE49-F238E27FC236}">
                  <a16:creationId xmlns:a16="http://schemas.microsoft.com/office/drawing/2014/main" id="{258EA96A-0965-2035-72F4-742C98CF8D61}"/>
                </a:ext>
              </a:extLst>
            </p:cNvPr>
            <p:cNvSpPr/>
            <p:nvPr/>
          </p:nvSpPr>
          <p:spPr>
            <a:xfrm>
              <a:off x="0" y="2430481"/>
              <a:ext cx="304892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fi-FI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Rectangle 106">
              <a:extLst>
                <a:ext uri="{FF2B5EF4-FFF2-40B4-BE49-F238E27FC236}">
                  <a16:creationId xmlns:a16="http://schemas.microsoft.com/office/drawing/2014/main" id="{B9021D76-C86F-85A7-1482-2E8B91E325E1}"/>
                </a:ext>
              </a:extLst>
            </p:cNvPr>
            <p:cNvSpPr/>
            <p:nvPr/>
          </p:nvSpPr>
          <p:spPr>
            <a:xfrm>
              <a:off x="3361595" y="2430481"/>
              <a:ext cx="314510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fi-FI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09086071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08BFD0BF-49ED-4645-B1C8-C119A6BC57C1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2935" y="755576"/>
            <a:ext cx="6273426" cy="73494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3311310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015454F7-EAC9-4A29-AEA5-1A9D0FB69B8A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207404" y="-693896"/>
            <a:ext cx="7065404" cy="136169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019397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9142</TotalTime>
  <Words>146</Words>
  <Application>Microsoft Office PowerPoint</Application>
  <PresentationFormat>On-screen Show (4:3)</PresentationFormat>
  <Paragraphs>14</Paragraphs>
  <Slides>6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新細明體</vt:lpstr>
      <vt:lpstr>Arial</vt:lpstr>
      <vt:lpstr>Calibri</vt:lpstr>
      <vt:lpstr>Times New Roman</vt:lpstr>
      <vt:lpstr>Office Theme</vt:lpstr>
      <vt:lpstr>Modulating Microglia/Macrophage Activation by CDNF Promotes Transplantation of Fetal Ventral Mesencephalic Graft Survival and Function in a Hemi-parkinsonian Rat Model</vt:lpstr>
      <vt:lpstr>Supplement</vt:lpstr>
      <vt:lpstr>PowerPoint Presentation</vt:lpstr>
      <vt:lpstr>PowerPoint Presentation</vt:lpstr>
      <vt:lpstr>PowerPoint Presentation</vt:lpstr>
      <vt:lpstr>PowerPoint Presentation</vt:lpstr>
    </vt:vector>
  </TitlesOfParts>
  <Company>University of Helsink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iravaar</dc:creator>
  <cp:lastModifiedBy>MDPI</cp:lastModifiedBy>
  <cp:revision>795</cp:revision>
  <cp:lastPrinted>2017-05-05T10:58:32Z</cp:lastPrinted>
  <dcterms:created xsi:type="dcterms:W3CDTF">2014-09-12T12:06:30Z</dcterms:created>
  <dcterms:modified xsi:type="dcterms:W3CDTF">2022-06-19T07:23:27Z</dcterms:modified>
</cp:coreProperties>
</file>